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FF2A63-F43D-4E04-AD56-2B2D60DDB8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AC716-DFE4-49A4-A768-1ECF81A713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5CD4BD-A47B-4F8E-8B41-59E9F9D20F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1B22D-7346-4B3F-B745-67FC562678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FD0B2C-4489-4010-832E-2C9BB1BA76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0BB6A8-895A-4A60-879A-7D78B1EDB7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F1D38-8D72-4E44-BF24-D6C0D3F865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8E9A0-8C6B-4371-BDD7-3C86757BC7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2E9A8-DD93-4C90-89C2-F799190B1B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AB43E-34FC-4E25-84FF-31897F45CF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7FFC29-E77C-400F-B234-D8B4DC408A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6E6FF-1532-4B42-84AC-29EB4E6C03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A3B16E0-4F69-4250-9E6A-057BFD3E0CFB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41184B8-9925-4E96-A690-31FCF7F498F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122400" y="914400"/>
            <a:ext cx="629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able S3. PQR dendrite defects in single and double mutants.</a:t>
            </a:r>
            <a:r>
              <a:rPr b="1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46240" y="1390680"/>
          <a:ext cx="6172200" cy="3986280"/>
        </p:xfrm>
        <a:graphic>
          <a:graphicData uri="http://schemas.openxmlformats.org/drawingml/2006/table">
            <a:tbl>
              <a:tblPr/>
              <a:tblGrid>
                <a:gridCol w="1600200"/>
                <a:gridCol w="831600"/>
                <a:gridCol w="833400"/>
                <a:gridCol w="833400"/>
                <a:gridCol w="831960"/>
                <a:gridCol w="833400"/>
                <a:gridCol w="408240"/>
              </a:tblGrid>
              <a:tr h="24588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5">
                  <a:txBody>
                    <a:bodyPr lIns="9000" rIns="9000" tIns="9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ndrite phenotype(%)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084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otyp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rma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hor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sen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teri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xtra Processes/Branch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yIs417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(W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44(n179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gl-20(n58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wn-1(ok546)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1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wn-2(ok89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1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44(n1792); egl-20(n58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44(n1792); cwn-1(ok546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wn-1(ok546); cwn-2(ok89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3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fz-2(ok120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g-1(e1787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1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17(vd00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2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17(n67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7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17(n309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17(n677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6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17(n677); lin-44(n179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17(n677); egl-20(n585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0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n-17(n677); mig-1(e1787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5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g-1(e1787); lin-44(n179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9T00:25:52Z</dcterms:created>
  <dc:creator>Leonie Kirszenblat</dc:creator>
  <dc:description/>
  <dc:language>en-US</dc:language>
  <cp:lastModifiedBy>Massimo Hilliard - Mobile</cp:lastModifiedBy>
  <dcterms:modified xsi:type="dcterms:W3CDTF">2011-02-09T07:03:57Z</dcterms:modified>
  <cp:revision>28</cp:revision>
  <dc:subject/>
  <dc:title>Slide 1</dc:title>
</cp:coreProperties>
</file>